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1557" r:id="rId2"/>
    <p:sldId id="1554" r:id="rId3"/>
    <p:sldId id="269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78" userDrawn="1">
          <p15:clr>
            <a:srgbClr val="A4A3A4"/>
          </p15:clr>
        </p15:guide>
        <p15:guide id="2" orient="horz" pos="48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42"/>
    <p:restoredTop sz="91429"/>
  </p:normalViewPr>
  <p:slideViewPr>
    <p:cSldViewPr snapToGrid="0" snapToObjects="1">
      <p:cViewPr varScale="1">
        <p:scale>
          <a:sx n="87" d="100"/>
          <a:sy n="87" d="100"/>
        </p:scale>
        <p:origin x="3656" y="208"/>
      </p:cViewPr>
      <p:guideLst>
        <p:guide pos="278"/>
        <p:guide orient="horz" pos="487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2D6D04-628D-014A-8DE6-67959C01CE9F}" type="datetimeFigureOut">
              <a:rPr lang="en-US" smtClean="0"/>
              <a:t>6/1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C7E49F-C997-604D-A3FB-9ECC1014B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717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C7E49F-C997-604D-A3FB-9ECC1014BEE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648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235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100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26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48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825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101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502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057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758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092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878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022A7-143A-0845-A610-5D5AF89CEC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339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D121BCBC-DCF4-FF42-B8CD-1B25E8A177EA}"/>
              </a:ext>
            </a:extLst>
          </p:cNvPr>
          <p:cNvGrpSpPr/>
          <p:nvPr/>
        </p:nvGrpSpPr>
        <p:grpSpPr>
          <a:xfrm>
            <a:off x="587370" y="643934"/>
            <a:ext cx="5943600" cy="2268382"/>
            <a:chOff x="457200" y="973823"/>
            <a:chExt cx="5943600" cy="226838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728AF68-2BE2-D24B-9E3E-0CD645C6A30E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00" y="973823"/>
              <a:ext cx="5943600" cy="110934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15B1237-0847-9640-B2F0-426CD8160B2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grayscl/>
            </a:blip>
            <a:stretch>
              <a:fillRect/>
            </a:stretch>
          </p:blipFill>
          <p:spPr>
            <a:xfrm>
              <a:off x="3636617" y="2264305"/>
              <a:ext cx="1625600" cy="97790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9CC8A30-916D-D64A-84FC-40BE3570975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grayscl/>
            </a:blip>
            <a:stretch>
              <a:fillRect/>
            </a:stretch>
          </p:blipFill>
          <p:spPr>
            <a:xfrm>
              <a:off x="1431318" y="2327805"/>
              <a:ext cx="1485900" cy="914400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E8AACCA9-2B8C-3341-977D-C94D1B8D95D4}"/>
              </a:ext>
            </a:extLst>
          </p:cNvPr>
          <p:cNvSpPr txBox="1"/>
          <p:nvPr/>
        </p:nvSpPr>
        <p:spPr>
          <a:xfrm>
            <a:off x="474667" y="136224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445A98-3908-C248-B2E0-6C062E08433A}"/>
              </a:ext>
            </a:extLst>
          </p:cNvPr>
          <p:cNvSpPr txBox="1"/>
          <p:nvPr/>
        </p:nvSpPr>
        <p:spPr>
          <a:xfrm>
            <a:off x="327030" y="50543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780EC82-F6C0-3C45-9252-FE39E80C3F76}"/>
              </a:ext>
            </a:extLst>
          </p:cNvPr>
          <p:cNvSpPr txBox="1"/>
          <p:nvPr/>
        </p:nvSpPr>
        <p:spPr>
          <a:xfrm>
            <a:off x="3766787" y="606682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933A9A0-017C-944A-916D-6F9FD6076D0B}"/>
              </a:ext>
            </a:extLst>
          </p:cNvPr>
          <p:cNvSpPr txBox="1"/>
          <p:nvPr/>
        </p:nvSpPr>
        <p:spPr>
          <a:xfrm>
            <a:off x="353833" y="3080474"/>
            <a:ext cx="323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C917864-C5F3-AC48-A3FD-8B6DFB0995A0}"/>
              </a:ext>
            </a:extLst>
          </p:cNvPr>
          <p:cNvSpPr txBox="1"/>
          <p:nvPr/>
        </p:nvSpPr>
        <p:spPr>
          <a:xfrm>
            <a:off x="360633" y="6066829"/>
            <a:ext cx="323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1690791-4B81-964F-AD64-67ACE41CCE1A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76" t="3480" r="67652" b="59521"/>
          <a:stretch/>
        </p:blipFill>
        <p:spPr>
          <a:xfrm>
            <a:off x="2188046" y="3292668"/>
            <a:ext cx="1395046" cy="2309447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0B54CAE-EE84-9040-BB5D-053C54FFB7B9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38" t="3480" r="22288" b="59521"/>
          <a:stretch/>
        </p:blipFill>
        <p:spPr>
          <a:xfrm>
            <a:off x="5155261" y="3292668"/>
            <a:ext cx="1383323" cy="230944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0D6869B2-5F00-3D4E-8435-481541262AA0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07" t="3480" b="59521"/>
          <a:stretch/>
        </p:blipFill>
        <p:spPr>
          <a:xfrm>
            <a:off x="3835898" y="3286155"/>
            <a:ext cx="1301260" cy="2309447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8687C053-3B07-5241-9B0D-60E2F9723593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53" t="3480" r="44970" b="59521"/>
          <a:stretch/>
        </p:blipFill>
        <p:spPr>
          <a:xfrm>
            <a:off x="684594" y="3292669"/>
            <a:ext cx="1371600" cy="230944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8EDFE98-2665-5A44-9597-4929467CFD0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0815" y="6212541"/>
            <a:ext cx="2590774" cy="219971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6E424BE-3156-864C-9B38-20D97F9C85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39349" y="6174064"/>
            <a:ext cx="2397310" cy="2198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41962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4AB7D8FD-FC8B-0D40-A295-BCFF85847F8B}"/>
              </a:ext>
            </a:extLst>
          </p:cNvPr>
          <p:cNvSpPr txBox="1"/>
          <p:nvPr/>
        </p:nvSpPr>
        <p:spPr>
          <a:xfrm>
            <a:off x="515814" y="372363"/>
            <a:ext cx="2029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.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96426F6-E475-E941-8AEE-EEAE8666D90A}"/>
              </a:ext>
            </a:extLst>
          </p:cNvPr>
          <p:cNvSpPr txBox="1"/>
          <p:nvPr/>
        </p:nvSpPr>
        <p:spPr>
          <a:xfrm>
            <a:off x="427561" y="960443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1FF366-5FDE-4946-AE25-A08D3EC00896}"/>
              </a:ext>
            </a:extLst>
          </p:cNvPr>
          <p:cNvSpPr txBox="1"/>
          <p:nvPr/>
        </p:nvSpPr>
        <p:spPr>
          <a:xfrm>
            <a:off x="426165" y="3723139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843BDB4-A578-1042-8CCF-6A3A26023C16}"/>
              </a:ext>
            </a:extLst>
          </p:cNvPr>
          <p:cNvSpPr txBox="1"/>
          <p:nvPr/>
        </p:nvSpPr>
        <p:spPr>
          <a:xfrm>
            <a:off x="3734645" y="371417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960B4D6-27EA-FC4F-A8E1-97604F1E7449}"/>
              </a:ext>
            </a:extLst>
          </p:cNvPr>
          <p:cNvSpPr txBox="1"/>
          <p:nvPr/>
        </p:nvSpPr>
        <p:spPr>
          <a:xfrm>
            <a:off x="3734645" y="941713"/>
            <a:ext cx="323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07442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F4D3252-1911-5743-97B3-9BFC4427A3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6737" y="4347882"/>
            <a:ext cx="2566508" cy="217095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E3834DF-1F9D-A044-82A6-206BAE6D5C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0725" y="4338919"/>
            <a:ext cx="2569183" cy="208802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FE980D3-15C6-474B-BBF4-5C52EA84D3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2307" y="1362635"/>
            <a:ext cx="2585063" cy="21784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5F937D7-E9BF-E047-BF53-3C56DAAB25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45111" y="1355228"/>
            <a:ext cx="2519830" cy="2106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4064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BACCEA7-D874-2D4C-85C5-DD2D56E85C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6597448"/>
              </p:ext>
            </p:extLst>
          </p:nvPr>
        </p:nvGraphicFramePr>
        <p:xfrm>
          <a:off x="851021" y="1503680"/>
          <a:ext cx="5472000" cy="178972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26315">
                  <a:extLst>
                    <a:ext uri="{9D8B030D-6E8A-4147-A177-3AD203B41FA5}">
                      <a16:colId xmlns:a16="http://schemas.microsoft.com/office/drawing/2014/main" val="431768971"/>
                    </a:ext>
                  </a:extLst>
                </a:gridCol>
                <a:gridCol w="2002056">
                  <a:extLst>
                    <a:ext uri="{9D8B030D-6E8A-4147-A177-3AD203B41FA5}">
                      <a16:colId xmlns:a16="http://schemas.microsoft.com/office/drawing/2014/main" val="1564373973"/>
                    </a:ext>
                  </a:extLst>
                </a:gridCol>
                <a:gridCol w="2043629">
                  <a:extLst>
                    <a:ext uri="{9D8B030D-6E8A-4147-A177-3AD203B41FA5}">
                      <a16:colId xmlns:a16="http://schemas.microsoft.com/office/drawing/2014/main" val="2171266546"/>
                    </a:ext>
                  </a:extLst>
                </a:gridCol>
              </a:tblGrid>
              <a:tr h="515328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effectLst/>
                        </a:rPr>
                        <a:t>Murine Gene</a:t>
                      </a:r>
                      <a:endParaRPr lang="en-CA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280" marR="132280" marT="132280" marB="132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Forward Primer</a:t>
                      </a:r>
                      <a:endParaRPr lang="en-CA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280" marR="132280" marT="132280" marB="132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Reverse Primer</a:t>
                      </a:r>
                      <a:endParaRPr lang="en-CA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2280" marR="132280" marT="132280" marB="132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3873011"/>
                  </a:ext>
                </a:extLst>
              </a:tr>
              <a:tr h="4248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effectLst/>
                        </a:rPr>
                        <a:t>HPRT</a:t>
                      </a:r>
                      <a:endParaRPr lang="en-CA" sz="105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CCGAGGATTTGGAAAAAGTGTT</a:t>
                      </a:r>
                      <a:endParaRPr lang="en-CA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CTTCATGACATCTCGAGCAAGT</a:t>
                      </a:r>
                      <a:endParaRPr lang="en-CA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9899158"/>
                  </a:ext>
                </a:extLst>
              </a:tr>
              <a:tr h="4248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effectLst/>
                        </a:rPr>
                        <a:t>LDLR</a:t>
                      </a:r>
                      <a:endParaRPr lang="en-CA" sz="105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</a:rPr>
                        <a:t>GGAGATGCACTTGCCATCCT</a:t>
                      </a:r>
                      <a:endParaRPr lang="en-CA" sz="1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AGGCTGTCCCCCCAAGAC</a:t>
                      </a:r>
                      <a:endParaRPr lang="en-CA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9584761"/>
                  </a:ext>
                </a:extLst>
              </a:tr>
              <a:tr h="4248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effectLst/>
                        </a:rPr>
                        <a:t>PCSK9</a:t>
                      </a:r>
                      <a:endParaRPr lang="en-CA" sz="105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CAGGGAGCACATTGCATCC</a:t>
                      </a:r>
                      <a:endParaRPr lang="en-CA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</a:rPr>
                        <a:t>TGCAAAATCAAGGAGCATGG</a:t>
                      </a:r>
                      <a:endParaRPr lang="en-CA" sz="1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6391484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F795D06B-4559-D641-9398-A2E3BAAF0EA4}"/>
              </a:ext>
            </a:extLst>
          </p:cNvPr>
          <p:cNvSpPr/>
          <p:nvPr/>
        </p:nvSpPr>
        <p:spPr>
          <a:xfrm>
            <a:off x="631565" y="324704"/>
            <a:ext cx="2518035" cy="3921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dirty="0"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1</a:t>
            </a:r>
            <a:endParaRPr lang="en-CA" sz="1600" dirty="0"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1312677"/>
      </p:ext>
    </p:extLst>
  </p:cSld>
  <p:clrMapOvr>
    <a:masterClrMapping/>
  </p:clrMapOvr>
</p:sld>
</file>

<file path=ppt/theme/theme1.xml><?xml version="1.0" encoding="utf-8"?>
<a:theme xmlns:a="http://schemas.openxmlformats.org/drawingml/2006/main" name="EOB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EOB" id="{EBD113E9-0A23-6742-B831-69AF23FDEF52}" vid="{F5D7668B-1190-2645-9362-8FEB2E547A35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24</TotalTime>
  <Words>35</Words>
  <Application>Microsoft Macintosh PowerPoint</Application>
  <PresentationFormat>Letter Paper (8.5x11 in)</PresentationFormat>
  <Paragraphs>2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EOB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O'Brien</dc:creator>
  <cp:lastModifiedBy>Edward O'Brien</cp:lastModifiedBy>
  <cp:revision>36</cp:revision>
  <dcterms:created xsi:type="dcterms:W3CDTF">2020-05-09T16:41:50Z</dcterms:created>
  <dcterms:modified xsi:type="dcterms:W3CDTF">2020-06-13T14:05:45Z</dcterms:modified>
</cp:coreProperties>
</file>